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553" r:id="rId5"/>
    <p:sldId id="525" r:id="rId6"/>
    <p:sldId id="532" r:id="rId7"/>
    <p:sldId id="533" r:id="rId8"/>
    <p:sldId id="534" r:id="rId9"/>
    <p:sldId id="535" r:id="rId10"/>
    <p:sldId id="538" r:id="rId11"/>
    <p:sldId id="536" r:id="rId12"/>
    <p:sldId id="537" r:id="rId13"/>
    <p:sldId id="539" r:id="rId14"/>
    <p:sldId id="556" r:id="rId15"/>
    <p:sldId id="557" r:id="rId16"/>
    <p:sldId id="558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uan-Ping" initials="H" lastIdx="1" clrIdx="0">
    <p:extLst>
      <p:ext uri="{19B8F6BF-5375-455C-9EA6-DF929625EA0E}">
        <p15:presenceInfo xmlns:p15="http://schemas.microsoft.com/office/powerpoint/2012/main" userId="2090fb55a20d35b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FFFF"/>
    <a:srgbClr val="CCFFCC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FB753EA-8224-48E0-AB57-71EA79992FB6}" v="23" dt="2024-01-19T09:42:45.92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2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microsoft.com/office/2015/10/relationships/revisionInfo" Target="revisionInfo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6/11/relationships/changesInfo" Target="changesInfos/changesInfo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O'Neal" userId="56ebcf1a-7abb-4491-bf50-219a1885c9d7" providerId="ADAL" clId="{3FB753EA-8224-48E0-AB57-71EA79992FB6}"/>
    <pc:docChg chg="undo redo custSel modSld">
      <pc:chgData name="David O'Neal" userId="56ebcf1a-7abb-4491-bf50-219a1885c9d7" providerId="ADAL" clId="{3FB753EA-8224-48E0-AB57-71EA79992FB6}" dt="2024-01-19T09:42:45.924" v="203" actId="164"/>
      <pc:docMkLst>
        <pc:docMk/>
      </pc:docMkLst>
      <pc:sldChg chg="addSp delSp modSp mod">
        <pc:chgData name="David O'Neal" userId="56ebcf1a-7abb-4491-bf50-219a1885c9d7" providerId="ADAL" clId="{3FB753EA-8224-48E0-AB57-71EA79992FB6}" dt="2024-01-19T09:42:45.924" v="203" actId="164"/>
        <pc:sldMkLst>
          <pc:docMk/>
          <pc:sldMk cId="3304879463" sldId="525"/>
        </pc:sldMkLst>
        <pc:spChg chg="add mod">
          <ac:chgData name="David O'Neal" userId="56ebcf1a-7abb-4491-bf50-219a1885c9d7" providerId="ADAL" clId="{3FB753EA-8224-48E0-AB57-71EA79992FB6}" dt="2024-01-19T09:42:45.924" v="203" actId="164"/>
          <ac:spMkLst>
            <pc:docMk/>
            <pc:sldMk cId="3304879463" sldId="525"/>
            <ac:spMk id="3" creationId="{3C23CA75-9D0A-43B3-F61E-FE45D6BBE054}"/>
          </ac:spMkLst>
        </pc:spChg>
        <pc:spChg chg="del">
          <ac:chgData name="David O'Neal" userId="56ebcf1a-7abb-4491-bf50-219a1885c9d7" providerId="ADAL" clId="{3FB753EA-8224-48E0-AB57-71EA79992FB6}" dt="2024-01-19T02:20:13.832" v="12" actId="478"/>
          <ac:spMkLst>
            <pc:docMk/>
            <pc:sldMk cId="3304879463" sldId="525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42:45.924" v="203" actId="164"/>
          <ac:grpSpMkLst>
            <pc:docMk/>
            <pc:sldMk cId="3304879463" sldId="525"/>
            <ac:grpSpMk id="4" creationId="{720CAAEE-5382-BC1D-BCFC-864318B5330A}"/>
          </ac:grpSpMkLst>
        </pc:grpChg>
        <pc:picChg chg="del">
          <ac:chgData name="David O'Neal" userId="56ebcf1a-7abb-4491-bf50-219a1885c9d7" providerId="ADAL" clId="{3FB753EA-8224-48E0-AB57-71EA79992FB6}" dt="2024-01-19T02:18:43.665" v="0" actId="478"/>
          <ac:picMkLst>
            <pc:docMk/>
            <pc:sldMk cId="3304879463" sldId="525"/>
            <ac:picMk id="4" creationId="{EAF14FD0-7378-2CDC-57E7-B6D2F2B18012}"/>
          </ac:picMkLst>
        </pc:picChg>
        <pc:picChg chg="mod modCrop">
          <ac:chgData name="David O'Neal" userId="56ebcf1a-7abb-4491-bf50-219a1885c9d7" providerId="ADAL" clId="{3FB753EA-8224-48E0-AB57-71EA79992FB6}" dt="2024-01-19T09:42:45.924" v="203" actId="164"/>
          <ac:picMkLst>
            <pc:docMk/>
            <pc:sldMk cId="3304879463" sldId="525"/>
            <ac:picMk id="6" creationId="{632A81B4-0F11-7E49-2E89-BE92B16C4199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34:23.712" v="163" actId="1076"/>
        <pc:sldMkLst>
          <pc:docMk/>
          <pc:sldMk cId="205092080" sldId="532"/>
        </pc:sldMkLst>
        <pc:spChg chg="add mod">
          <ac:chgData name="David O'Neal" userId="56ebcf1a-7abb-4491-bf50-219a1885c9d7" providerId="ADAL" clId="{3FB753EA-8224-48E0-AB57-71EA79992FB6}" dt="2024-01-19T09:34:23.712" v="163" actId="1076"/>
          <ac:spMkLst>
            <pc:docMk/>
            <pc:sldMk cId="205092080" sldId="532"/>
            <ac:spMk id="3" creationId="{EE12F1B0-9292-3564-6653-85A4E3FA3115}"/>
          </ac:spMkLst>
        </pc:spChg>
        <pc:spChg chg="del">
          <ac:chgData name="David O'Neal" userId="56ebcf1a-7abb-4491-bf50-219a1885c9d7" providerId="ADAL" clId="{3FB753EA-8224-48E0-AB57-71EA79992FB6}" dt="2024-01-19T02:20:28.996" v="15" actId="478"/>
          <ac:spMkLst>
            <pc:docMk/>
            <pc:sldMk cId="205092080" sldId="532"/>
            <ac:spMk id="14" creationId="{E79851DC-02ED-4939-A415-558B1B91E443}"/>
          </ac:spMkLst>
        </pc:spChg>
        <pc:picChg chg="del">
          <ac:chgData name="David O'Neal" userId="56ebcf1a-7abb-4491-bf50-219a1885c9d7" providerId="ADAL" clId="{3FB753EA-8224-48E0-AB57-71EA79992FB6}" dt="2024-01-19T02:18:49.649" v="1" actId="478"/>
          <ac:picMkLst>
            <pc:docMk/>
            <pc:sldMk cId="205092080" sldId="532"/>
            <ac:picMk id="3" creationId="{B41709DF-BA02-D6F4-26A9-78133122A2D9}"/>
          </ac:picMkLst>
        </pc:picChg>
        <pc:picChg chg="mod">
          <ac:chgData name="David O'Neal" userId="56ebcf1a-7abb-4491-bf50-219a1885c9d7" providerId="ADAL" clId="{3FB753EA-8224-48E0-AB57-71EA79992FB6}" dt="2024-01-19T02:20:37.116" v="17" actId="14100"/>
          <ac:picMkLst>
            <pc:docMk/>
            <pc:sldMk cId="205092080" sldId="532"/>
            <ac:picMk id="5" creationId="{86D788D2-039C-BDA3-E61D-216E9EF817F6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34:57.870" v="168" actId="1076"/>
        <pc:sldMkLst>
          <pc:docMk/>
          <pc:sldMk cId="697920974" sldId="533"/>
        </pc:sldMkLst>
        <pc:spChg chg="add mod">
          <ac:chgData name="David O'Neal" userId="56ebcf1a-7abb-4491-bf50-219a1885c9d7" providerId="ADAL" clId="{3FB753EA-8224-48E0-AB57-71EA79992FB6}" dt="2024-01-19T09:34:57.870" v="168" actId="1076"/>
          <ac:spMkLst>
            <pc:docMk/>
            <pc:sldMk cId="697920974" sldId="533"/>
            <ac:spMk id="3" creationId="{4605C983-F33A-EEE9-42DC-9A56C398B098}"/>
          </ac:spMkLst>
        </pc:spChg>
        <pc:spChg chg="del">
          <ac:chgData name="David O'Neal" userId="56ebcf1a-7abb-4491-bf50-219a1885c9d7" providerId="ADAL" clId="{3FB753EA-8224-48E0-AB57-71EA79992FB6}" dt="2024-01-19T02:20:45.882" v="18" actId="478"/>
          <ac:spMkLst>
            <pc:docMk/>
            <pc:sldMk cId="697920974" sldId="533"/>
            <ac:spMk id="14" creationId="{E79851DC-02ED-4939-A415-558B1B91E443}"/>
          </ac:spMkLst>
        </pc:spChg>
        <pc:picChg chg="del">
          <ac:chgData name="David O'Neal" userId="56ebcf1a-7abb-4491-bf50-219a1885c9d7" providerId="ADAL" clId="{3FB753EA-8224-48E0-AB57-71EA79992FB6}" dt="2024-01-19T02:18:55.186" v="2" actId="478"/>
          <ac:picMkLst>
            <pc:docMk/>
            <pc:sldMk cId="697920974" sldId="533"/>
            <ac:picMk id="4" creationId="{65D13779-A9BE-5545-14CE-2478084F9619}"/>
          </ac:picMkLst>
        </pc:picChg>
        <pc:picChg chg="mod">
          <ac:chgData name="David O'Neal" userId="56ebcf1a-7abb-4491-bf50-219a1885c9d7" providerId="ADAL" clId="{3FB753EA-8224-48E0-AB57-71EA79992FB6}" dt="2024-01-19T02:20:54.908" v="20" actId="14100"/>
          <ac:picMkLst>
            <pc:docMk/>
            <pc:sldMk cId="697920974" sldId="533"/>
            <ac:picMk id="5" creationId="{E0187D96-13D8-5F54-131D-EAE593E0CF67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42:18.750" v="202" actId="164"/>
        <pc:sldMkLst>
          <pc:docMk/>
          <pc:sldMk cId="3884756579" sldId="534"/>
        </pc:sldMkLst>
        <pc:spChg chg="add mod">
          <ac:chgData name="David O'Neal" userId="56ebcf1a-7abb-4491-bf50-219a1885c9d7" providerId="ADAL" clId="{3FB753EA-8224-48E0-AB57-71EA79992FB6}" dt="2024-01-19T09:42:18.750" v="202" actId="164"/>
          <ac:spMkLst>
            <pc:docMk/>
            <pc:sldMk cId="3884756579" sldId="534"/>
            <ac:spMk id="3" creationId="{1826938B-8E45-81FC-1B0F-3471B7C1214A}"/>
          </ac:spMkLst>
        </pc:spChg>
        <pc:spChg chg="del">
          <ac:chgData name="David O'Neal" userId="56ebcf1a-7abb-4491-bf50-219a1885c9d7" providerId="ADAL" clId="{3FB753EA-8224-48E0-AB57-71EA79992FB6}" dt="2024-01-19T02:20:59.268" v="21" actId="478"/>
          <ac:spMkLst>
            <pc:docMk/>
            <pc:sldMk cId="3884756579" sldId="534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42:18.750" v="202" actId="164"/>
          <ac:grpSpMkLst>
            <pc:docMk/>
            <pc:sldMk cId="3884756579" sldId="534"/>
            <ac:grpSpMk id="4" creationId="{09AE1E84-6DBE-91FB-4448-2C1987220392}"/>
          </ac:grpSpMkLst>
        </pc:grpChg>
        <pc:picChg chg="del">
          <ac:chgData name="David O'Neal" userId="56ebcf1a-7abb-4491-bf50-219a1885c9d7" providerId="ADAL" clId="{3FB753EA-8224-48E0-AB57-71EA79992FB6}" dt="2024-01-19T02:19:01.272" v="3" actId="478"/>
          <ac:picMkLst>
            <pc:docMk/>
            <pc:sldMk cId="3884756579" sldId="534"/>
            <ac:picMk id="5" creationId="{44A8E3DB-B465-4137-A18E-BEE10D58B851}"/>
          </ac:picMkLst>
        </pc:picChg>
        <pc:picChg chg="mod">
          <ac:chgData name="David O'Neal" userId="56ebcf1a-7abb-4491-bf50-219a1885c9d7" providerId="ADAL" clId="{3FB753EA-8224-48E0-AB57-71EA79992FB6}" dt="2024-01-19T09:42:18.750" v="202" actId="164"/>
          <ac:picMkLst>
            <pc:docMk/>
            <pc:sldMk cId="3884756579" sldId="534"/>
            <ac:picMk id="6" creationId="{15002525-D405-D86E-FE81-496A5688021E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35:51.624" v="171" actId="1076"/>
        <pc:sldMkLst>
          <pc:docMk/>
          <pc:sldMk cId="2722441923" sldId="535"/>
        </pc:sldMkLst>
        <pc:spChg chg="add mod">
          <ac:chgData name="David O'Neal" userId="56ebcf1a-7abb-4491-bf50-219a1885c9d7" providerId="ADAL" clId="{3FB753EA-8224-48E0-AB57-71EA79992FB6}" dt="2024-01-19T09:35:51.624" v="171" actId="1076"/>
          <ac:spMkLst>
            <pc:docMk/>
            <pc:sldMk cId="2722441923" sldId="535"/>
            <ac:spMk id="3" creationId="{4CD2C784-E8F3-03F8-F24F-9D3AF4EE02F4}"/>
          </ac:spMkLst>
        </pc:spChg>
        <pc:spChg chg="del">
          <ac:chgData name="David O'Neal" userId="56ebcf1a-7abb-4491-bf50-219a1885c9d7" providerId="ADAL" clId="{3FB753EA-8224-48E0-AB57-71EA79992FB6}" dt="2024-01-19T02:21:21.396" v="24" actId="478"/>
          <ac:spMkLst>
            <pc:docMk/>
            <pc:sldMk cId="2722441923" sldId="535"/>
            <ac:spMk id="14" creationId="{E79851DC-02ED-4939-A415-558B1B91E443}"/>
          </ac:spMkLst>
        </pc:spChg>
        <pc:picChg chg="mod">
          <ac:chgData name="David O'Neal" userId="56ebcf1a-7abb-4491-bf50-219a1885c9d7" providerId="ADAL" clId="{3FB753EA-8224-48E0-AB57-71EA79992FB6}" dt="2024-01-19T02:21:58.394" v="36" actId="14100"/>
          <ac:picMkLst>
            <pc:docMk/>
            <pc:sldMk cId="2722441923" sldId="535"/>
            <ac:picMk id="7" creationId="{C6F4F786-30AF-E81B-BBB3-A21D2163939B}"/>
          </ac:picMkLst>
        </pc:picChg>
        <pc:picChg chg="del">
          <ac:chgData name="David O'Neal" userId="56ebcf1a-7abb-4491-bf50-219a1885c9d7" providerId="ADAL" clId="{3FB753EA-8224-48E0-AB57-71EA79992FB6}" dt="2024-01-19T02:19:09.581" v="4" actId="478"/>
          <ac:picMkLst>
            <pc:docMk/>
            <pc:sldMk cId="2722441923" sldId="535"/>
            <ac:picMk id="8" creationId="{A7F32872-0DEF-5B9A-E56D-BCA1956F6ED9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40:53.114" v="194" actId="164"/>
        <pc:sldMkLst>
          <pc:docMk/>
          <pc:sldMk cId="494528939" sldId="536"/>
        </pc:sldMkLst>
        <pc:spChg chg="add mod">
          <ac:chgData name="David O'Neal" userId="56ebcf1a-7abb-4491-bf50-219a1885c9d7" providerId="ADAL" clId="{3FB753EA-8224-48E0-AB57-71EA79992FB6}" dt="2024-01-19T09:40:53.114" v="194" actId="164"/>
          <ac:spMkLst>
            <pc:docMk/>
            <pc:sldMk cId="494528939" sldId="536"/>
            <ac:spMk id="3" creationId="{A32E65D5-C402-5D0E-D61B-EEE6D86786C6}"/>
          </ac:spMkLst>
        </pc:spChg>
        <pc:spChg chg="add mod">
          <ac:chgData name="David O'Neal" userId="56ebcf1a-7abb-4491-bf50-219a1885c9d7" providerId="ADAL" clId="{3FB753EA-8224-48E0-AB57-71EA79992FB6}" dt="2024-01-19T09:40:53.114" v="194" actId="164"/>
          <ac:spMkLst>
            <pc:docMk/>
            <pc:sldMk cId="494528939" sldId="536"/>
            <ac:spMk id="4" creationId="{4C980F22-CFBE-6C28-39C1-0B844AE88F54}"/>
          </ac:spMkLst>
        </pc:spChg>
        <pc:spChg chg="mod">
          <ac:chgData name="David O'Neal" userId="56ebcf1a-7abb-4491-bf50-219a1885c9d7" providerId="ADAL" clId="{3FB753EA-8224-48E0-AB57-71EA79992FB6}" dt="2024-01-19T09:32:18.180" v="152" actId="207"/>
          <ac:spMkLst>
            <pc:docMk/>
            <pc:sldMk cId="494528939" sldId="536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40:53.114" v="194" actId="164"/>
          <ac:grpSpMkLst>
            <pc:docMk/>
            <pc:sldMk cId="494528939" sldId="536"/>
            <ac:grpSpMk id="6" creationId="{91619A2F-A5DB-D15B-458F-C77B6EA321C6}"/>
          </ac:grpSpMkLst>
        </pc:grpChg>
        <pc:picChg chg="del">
          <ac:chgData name="David O'Neal" userId="56ebcf1a-7abb-4491-bf50-219a1885c9d7" providerId="ADAL" clId="{3FB753EA-8224-48E0-AB57-71EA79992FB6}" dt="2024-01-19T02:19:22.426" v="6" actId="478"/>
          <ac:picMkLst>
            <pc:docMk/>
            <pc:sldMk cId="494528939" sldId="536"/>
            <ac:picMk id="4" creationId="{8DF54FB9-25E9-74A9-13E7-8D58F42F7686}"/>
          </ac:picMkLst>
        </pc:picChg>
        <pc:picChg chg="mod">
          <ac:chgData name="David O'Neal" userId="56ebcf1a-7abb-4491-bf50-219a1885c9d7" providerId="ADAL" clId="{3FB753EA-8224-48E0-AB57-71EA79992FB6}" dt="2024-01-19T09:40:53.114" v="194" actId="164"/>
          <ac:picMkLst>
            <pc:docMk/>
            <pc:sldMk cId="494528939" sldId="536"/>
            <ac:picMk id="5" creationId="{9D2EA9E0-6E50-E348-97B0-D18601F7B1B9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41:04.114" v="195" actId="164"/>
        <pc:sldMkLst>
          <pc:docMk/>
          <pc:sldMk cId="2582301326" sldId="537"/>
        </pc:sldMkLst>
        <pc:spChg chg="add mod">
          <ac:chgData name="David O'Neal" userId="56ebcf1a-7abb-4491-bf50-219a1885c9d7" providerId="ADAL" clId="{3FB753EA-8224-48E0-AB57-71EA79992FB6}" dt="2024-01-19T09:41:04.114" v="195" actId="164"/>
          <ac:spMkLst>
            <pc:docMk/>
            <pc:sldMk cId="2582301326" sldId="537"/>
            <ac:spMk id="3" creationId="{EF58944E-BE67-1C52-5771-07B30A343233}"/>
          </ac:spMkLst>
        </pc:spChg>
        <pc:spChg chg="del">
          <ac:chgData name="David O'Neal" userId="56ebcf1a-7abb-4491-bf50-219a1885c9d7" providerId="ADAL" clId="{3FB753EA-8224-48E0-AB57-71EA79992FB6}" dt="2024-01-19T02:22:50.081" v="51" actId="478"/>
          <ac:spMkLst>
            <pc:docMk/>
            <pc:sldMk cId="2582301326" sldId="537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41:04.114" v="195" actId="164"/>
          <ac:grpSpMkLst>
            <pc:docMk/>
            <pc:sldMk cId="2582301326" sldId="537"/>
            <ac:grpSpMk id="5" creationId="{5B9A9D19-7BA8-7DC9-2007-812109DEE912}"/>
          </ac:grpSpMkLst>
        </pc:grpChg>
        <pc:picChg chg="mod">
          <ac:chgData name="David O'Neal" userId="56ebcf1a-7abb-4491-bf50-219a1885c9d7" providerId="ADAL" clId="{3FB753EA-8224-48E0-AB57-71EA79992FB6}" dt="2024-01-19T09:41:04.114" v="195" actId="164"/>
          <ac:picMkLst>
            <pc:docMk/>
            <pc:sldMk cId="2582301326" sldId="537"/>
            <ac:picMk id="4" creationId="{1E66112F-B325-A089-7ABB-7C833C71EABE}"/>
          </ac:picMkLst>
        </pc:picChg>
        <pc:picChg chg="del">
          <ac:chgData name="David O'Neal" userId="56ebcf1a-7abb-4491-bf50-219a1885c9d7" providerId="ADAL" clId="{3FB753EA-8224-48E0-AB57-71EA79992FB6}" dt="2024-01-19T02:19:30.296" v="7" actId="478"/>
          <ac:picMkLst>
            <pc:docMk/>
            <pc:sldMk cId="2582301326" sldId="537"/>
            <ac:picMk id="6" creationId="{6FE34B1F-5E23-2028-EEFF-060C50FFA0B3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40:30.368" v="193" actId="164"/>
        <pc:sldMkLst>
          <pc:docMk/>
          <pc:sldMk cId="2921507561" sldId="538"/>
        </pc:sldMkLst>
        <pc:spChg chg="add mod">
          <ac:chgData name="David O'Neal" userId="56ebcf1a-7abb-4491-bf50-219a1885c9d7" providerId="ADAL" clId="{3FB753EA-8224-48E0-AB57-71EA79992FB6}" dt="2024-01-19T09:40:30.368" v="193" actId="164"/>
          <ac:spMkLst>
            <pc:docMk/>
            <pc:sldMk cId="2921507561" sldId="538"/>
            <ac:spMk id="4" creationId="{28A85082-F48C-C017-402E-420F4E79EDB3}"/>
          </ac:spMkLst>
        </pc:spChg>
        <pc:spChg chg="add del">
          <ac:chgData name="David O'Neal" userId="56ebcf1a-7abb-4491-bf50-219a1885c9d7" providerId="ADAL" clId="{3FB753EA-8224-48E0-AB57-71EA79992FB6}" dt="2024-01-19T02:22:11.486" v="43" actId="478"/>
          <ac:spMkLst>
            <pc:docMk/>
            <pc:sldMk cId="2921507561" sldId="538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40:30.368" v="193" actId="164"/>
          <ac:grpSpMkLst>
            <pc:docMk/>
            <pc:sldMk cId="2921507561" sldId="538"/>
            <ac:grpSpMk id="5" creationId="{C8DBD7D1-AD20-38B4-BCE6-1BE4D3C53D69}"/>
          </ac:grpSpMkLst>
        </pc:grpChg>
        <pc:picChg chg="mod">
          <ac:chgData name="David O'Neal" userId="56ebcf1a-7abb-4491-bf50-219a1885c9d7" providerId="ADAL" clId="{3FB753EA-8224-48E0-AB57-71EA79992FB6}" dt="2024-01-19T09:40:30.368" v="193" actId="164"/>
          <ac:picMkLst>
            <pc:docMk/>
            <pc:sldMk cId="2921507561" sldId="538"/>
            <ac:picMk id="3" creationId="{41781EA8-D04D-0A97-F69A-148AB343DF05}"/>
          </ac:picMkLst>
        </pc:picChg>
        <pc:picChg chg="del">
          <ac:chgData name="David O'Neal" userId="56ebcf1a-7abb-4491-bf50-219a1885c9d7" providerId="ADAL" clId="{3FB753EA-8224-48E0-AB57-71EA79992FB6}" dt="2024-01-19T02:19:18.409" v="5" actId="478"/>
          <ac:picMkLst>
            <pc:docMk/>
            <pc:sldMk cId="2921507561" sldId="538"/>
            <ac:picMk id="4" creationId="{7211023C-8D15-53DB-B6E0-35D0DF5BFDC2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42:02.567" v="201" actId="1076"/>
        <pc:sldMkLst>
          <pc:docMk/>
          <pc:sldMk cId="2974478113" sldId="539"/>
        </pc:sldMkLst>
        <pc:spChg chg="add del mod">
          <ac:chgData name="David O'Neal" userId="56ebcf1a-7abb-4491-bf50-219a1885c9d7" providerId="ADAL" clId="{3FB753EA-8224-48E0-AB57-71EA79992FB6}" dt="2024-01-19T09:27:52.071" v="133" actId="478"/>
          <ac:spMkLst>
            <pc:docMk/>
            <pc:sldMk cId="2974478113" sldId="539"/>
            <ac:spMk id="5" creationId="{31C18E2B-EF73-AC19-2888-339A1962FDCE}"/>
          </ac:spMkLst>
        </pc:spChg>
        <pc:spChg chg="add mod">
          <ac:chgData name="David O'Neal" userId="56ebcf1a-7abb-4491-bf50-219a1885c9d7" providerId="ADAL" clId="{3FB753EA-8224-48E0-AB57-71EA79992FB6}" dt="2024-01-19T09:31:59.231" v="151" actId="207"/>
          <ac:spMkLst>
            <pc:docMk/>
            <pc:sldMk cId="2974478113" sldId="539"/>
            <ac:spMk id="6" creationId="{FE325ECE-8CF0-CEA0-E353-539568C3D54C}"/>
          </ac:spMkLst>
        </pc:spChg>
        <pc:spChg chg="add del mod">
          <ac:chgData name="David O'Neal" userId="56ebcf1a-7abb-4491-bf50-219a1885c9d7" providerId="ADAL" clId="{3FB753EA-8224-48E0-AB57-71EA79992FB6}" dt="2024-01-19T09:30:47.378" v="140" actId="478"/>
          <ac:spMkLst>
            <pc:docMk/>
            <pc:sldMk cId="2974478113" sldId="539"/>
            <ac:spMk id="8" creationId="{3A7475BA-5FA5-DCA6-E68D-7F7E35286865}"/>
          </ac:spMkLst>
        </pc:spChg>
        <pc:spChg chg="add mod">
          <ac:chgData name="David O'Neal" userId="56ebcf1a-7abb-4491-bf50-219a1885c9d7" providerId="ADAL" clId="{3FB753EA-8224-48E0-AB57-71EA79992FB6}" dt="2024-01-19T09:37:11.824" v="179" actId="1076"/>
          <ac:spMkLst>
            <pc:docMk/>
            <pc:sldMk cId="2974478113" sldId="539"/>
            <ac:spMk id="9" creationId="{AA1FD17E-ADE2-38DA-8D30-E60B90318D91}"/>
          </ac:spMkLst>
        </pc:spChg>
        <pc:spChg chg="add mod">
          <ac:chgData name="David O'Neal" userId="56ebcf1a-7abb-4491-bf50-219a1885c9d7" providerId="ADAL" clId="{3FB753EA-8224-48E0-AB57-71EA79992FB6}" dt="2024-01-19T09:37:22.740" v="182" actId="1076"/>
          <ac:spMkLst>
            <pc:docMk/>
            <pc:sldMk cId="2974478113" sldId="539"/>
            <ac:spMk id="10" creationId="{FE97E43E-98D1-C01B-2D56-A0865D3BBC0C}"/>
          </ac:spMkLst>
        </pc:spChg>
        <pc:spChg chg="add mod">
          <ac:chgData name="David O'Neal" userId="56ebcf1a-7abb-4491-bf50-219a1885c9d7" providerId="ADAL" clId="{3FB753EA-8224-48E0-AB57-71EA79992FB6}" dt="2024-01-19T09:42:02.567" v="201" actId="1076"/>
          <ac:spMkLst>
            <pc:docMk/>
            <pc:sldMk cId="2974478113" sldId="539"/>
            <ac:spMk id="11" creationId="{B430845B-1748-5728-B854-0FB8ACBDA9B8}"/>
          </ac:spMkLst>
        </pc:spChg>
        <pc:spChg chg="del">
          <ac:chgData name="David O'Neal" userId="56ebcf1a-7abb-4491-bf50-219a1885c9d7" providerId="ADAL" clId="{3FB753EA-8224-48E0-AB57-71EA79992FB6}" dt="2024-01-19T09:28:35.105" v="135" actId="478"/>
          <ac:spMkLst>
            <pc:docMk/>
            <pc:sldMk cId="2974478113" sldId="539"/>
            <ac:spMk id="14" creationId="{E79851DC-02ED-4939-A415-558B1B91E443}"/>
          </ac:spMkLst>
        </pc:spChg>
        <pc:picChg chg="mod">
          <ac:chgData name="David O'Neal" userId="56ebcf1a-7abb-4491-bf50-219a1885c9d7" providerId="ADAL" clId="{3FB753EA-8224-48E0-AB57-71EA79992FB6}" dt="2024-01-19T02:23:20.399" v="57" actId="14100"/>
          <ac:picMkLst>
            <pc:docMk/>
            <pc:sldMk cId="2974478113" sldId="539"/>
            <ac:picMk id="3" creationId="{A6032327-16E1-B8B6-07C9-DAAF8482E293}"/>
          </ac:picMkLst>
        </pc:picChg>
        <pc:picChg chg="del">
          <ac:chgData name="David O'Neal" userId="56ebcf1a-7abb-4491-bf50-219a1885c9d7" providerId="ADAL" clId="{3FB753EA-8224-48E0-AB57-71EA79992FB6}" dt="2024-01-19T02:19:35.481" v="8" actId="478"/>
          <ac:picMkLst>
            <pc:docMk/>
            <pc:sldMk cId="2974478113" sldId="539"/>
            <ac:picMk id="5" creationId="{3199F720-953E-2643-337F-6A259199C8AC}"/>
          </ac:picMkLst>
        </pc:picChg>
      </pc:sldChg>
      <pc:sldChg chg="delSp modSp mod">
        <pc:chgData name="David O'Neal" userId="56ebcf1a-7abb-4491-bf50-219a1885c9d7" providerId="ADAL" clId="{3FB753EA-8224-48E0-AB57-71EA79992FB6}" dt="2024-01-19T02:25:41.284" v="95" actId="20577"/>
        <pc:sldMkLst>
          <pc:docMk/>
          <pc:sldMk cId="2441710235" sldId="553"/>
        </pc:sldMkLst>
        <pc:spChg chg="del">
          <ac:chgData name="David O'Neal" userId="56ebcf1a-7abb-4491-bf50-219a1885c9d7" providerId="ADAL" clId="{3FB753EA-8224-48E0-AB57-71EA79992FB6}" dt="2024-01-19T02:24:36.410" v="67" actId="478"/>
          <ac:spMkLst>
            <pc:docMk/>
            <pc:sldMk cId="2441710235" sldId="553"/>
            <ac:spMk id="2" creationId="{5BB086DA-4AEC-07FE-0AB0-E10120D1783B}"/>
          </ac:spMkLst>
        </pc:spChg>
        <pc:spChg chg="mod">
          <ac:chgData name="David O'Neal" userId="56ebcf1a-7abb-4491-bf50-219a1885c9d7" providerId="ADAL" clId="{3FB753EA-8224-48E0-AB57-71EA79992FB6}" dt="2024-01-19T02:25:41.284" v="95" actId="20577"/>
          <ac:spMkLst>
            <pc:docMk/>
            <pc:sldMk cId="2441710235" sldId="553"/>
            <ac:spMk id="3" creationId="{353A2846-4A71-C539-F78E-8F87D620FC7A}"/>
          </ac:spMkLst>
        </pc:spChg>
      </pc:sldChg>
      <pc:sldChg chg="addSp delSp modSp mod">
        <pc:chgData name="David O'Neal" userId="56ebcf1a-7abb-4491-bf50-219a1885c9d7" providerId="ADAL" clId="{3FB753EA-8224-48E0-AB57-71EA79992FB6}" dt="2024-01-19T09:39:21.983" v="191" actId="164"/>
        <pc:sldMkLst>
          <pc:docMk/>
          <pc:sldMk cId="2915905150" sldId="556"/>
        </pc:sldMkLst>
        <pc:spChg chg="add mod">
          <ac:chgData name="David O'Neal" userId="56ebcf1a-7abb-4491-bf50-219a1885c9d7" providerId="ADAL" clId="{3FB753EA-8224-48E0-AB57-71EA79992FB6}" dt="2024-01-19T09:39:21.983" v="191" actId="164"/>
          <ac:spMkLst>
            <pc:docMk/>
            <pc:sldMk cId="2915905150" sldId="556"/>
            <ac:spMk id="3" creationId="{D36215FB-31F2-035C-5D68-1CC15A23AA25}"/>
          </ac:spMkLst>
        </pc:spChg>
        <pc:spChg chg="del">
          <ac:chgData name="David O'Neal" userId="56ebcf1a-7abb-4491-bf50-219a1885c9d7" providerId="ADAL" clId="{3FB753EA-8224-48E0-AB57-71EA79992FB6}" dt="2024-01-19T02:23:31.527" v="58" actId="478"/>
          <ac:spMkLst>
            <pc:docMk/>
            <pc:sldMk cId="2915905150" sldId="556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39:21.983" v="191" actId="164"/>
          <ac:grpSpMkLst>
            <pc:docMk/>
            <pc:sldMk cId="2915905150" sldId="556"/>
            <ac:grpSpMk id="5" creationId="{A153C75F-C133-AFF0-558F-C39EF9195CCF}"/>
          </ac:grpSpMkLst>
        </pc:grpChg>
        <pc:picChg chg="mod">
          <ac:chgData name="David O'Neal" userId="56ebcf1a-7abb-4491-bf50-219a1885c9d7" providerId="ADAL" clId="{3FB753EA-8224-48E0-AB57-71EA79992FB6}" dt="2024-01-19T09:39:21.983" v="191" actId="164"/>
          <ac:picMkLst>
            <pc:docMk/>
            <pc:sldMk cId="2915905150" sldId="556"/>
            <ac:picMk id="4" creationId="{4691E8EC-D31C-DAA0-41A5-F25E27E3DD05}"/>
          </ac:picMkLst>
        </pc:picChg>
        <pc:picChg chg="del">
          <ac:chgData name="David O'Neal" userId="56ebcf1a-7abb-4491-bf50-219a1885c9d7" providerId="ADAL" clId="{3FB753EA-8224-48E0-AB57-71EA79992FB6}" dt="2024-01-19T02:19:42.895" v="9" actId="478"/>
          <ac:picMkLst>
            <pc:docMk/>
            <pc:sldMk cId="2915905150" sldId="556"/>
            <ac:picMk id="6" creationId="{C7B6BA53-8D06-4877-6601-E97CE9D8AB81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39:07.638" v="190" actId="164"/>
        <pc:sldMkLst>
          <pc:docMk/>
          <pc:sldMk cId="1306286101" sldId="557"/>
        </pc:sldMkLst>
        <pc:spChg chg="add mod">
          <ac:chgData name="David O'Neal" userId="56ebcf1a-7abb-4491-bf50-219a1885c9d7" providerId="ADAL" clId="{3FB753EA-8224-48E0-AB57-71EA79992FB6}" dt="2024-01-19T09:39:07.638" v="190" actId="164"/>
          <ac:spMkLst>
            <pc:docMk/>
            <pc:sldMk cId="1306286101" sldId="557"/>
            <ac:spMk id="3" creationId="{BCEA7EA0-B65F-C59B-895E-69537C2DA9D1}"/>
          </ac:spMkLst>
        </pc:spChg>
        <pc:spChg chg="del">
          <ac:chgData name="David O'Neal" userId="56ebcf1a-7abb-4491-bf50-219a1885c9d7" providerId="ADAL" clId="{3FB753EA-8224-48E0-AB57-71EA79992FB6}" dt="2024-01-19T02:23:48.439" v="61" actId="478"/>
          <ac:spMkLst>
            <pc:docMk/>
            <pc:sldMk cId="1306286101" sldId="557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39:07.638" v="190" actId="164"/>
          <ac:grpSpMkLst>
            <pc:docMk/>
            <pc:sldMk cId="1306286101" sldId="557"/>
            <ac:grpSpMk id="4" creationId="{4F029C0F-E428-04C7-EDB4-833B41AD4BE6}"/>
          </ac:grpSpMkLst>
        </pc:grpChg>
        <pc:picChg chg="mod">
          <ac:chgData name="David O'Neal" userId="56ebcf1a-7abb-4491-bf50-219a1885c9d7" providerId="ADAL" clId="{3FB753EA-8224-48E0-AB57-71EA79992FB6}" dt="2024-01-19T09:39:07.638" v="190" actId="164"/>
          <ac:picMkLst>
            <pc:docMk/>
            <pc:sldMk cId="1306286101" sldId="557"/>
            <ac:picMk id="5" creationId="{023A66E0-E4CC-356A-3F7E-D20E62100B09}"/>
          </ac:picMkLst>
        </pc:picChg>
        <pc:picChg chg="del">
          <ac:chgData name="David O'Neal" userId="56ebcf1a-7abb-4491-bf50-219a1885c9d7" providerId="ADAL" clId="{3FB753EA-8224-48E0-AB57-71EA79992FB6}" dt="2024-01-19T02:19:47.547" v="10" actId="478"/>
          <ac:picMkLst>
            <pc:docMk/>
            <pc:sldMk cId="1306286101" sldId="557"/>
            <ac:picMk id="6" creationId="{8053054E-77C9-DC9E-0D52-8CE34E4CDEB6}"/>
          </ac:picMkLst>
        </pc:picChg>
      </pc:sldChg>
      <pc:sldChg chg="addSp delSp modSp mod">
        <pc:chgData name="David O'Neal" userId="56ebcf1a-7abb-4491-bf50-219a1885c9d7" providerId="ADAL" clId="{3FB753EA-8224-48E0-AB57-71EA79992FB6}" dt="2024-01-19T09:38:50.604" v="189" actId="164"/>
        <pc:sldMkLst>
          <pc:docMk/>
          <pc:sldMk cId="1988924823" sldId="558"/>
        </pc:sldMkLst>
        <pc:spChg chg="add mod">
          <ac:chgData name="David O'Neal" userId="56ebcf1a-7abb-4491-bf50-219a1885c9d7" providerId="ADAL" clId="{3FB753EA-8224-48E0-AB57-71EA79992FB6}" dt="2024-01-19T09:38:50.604" v="189" actId="164"/>
          <ac:spMkLst>
            <pc:docMk/>
            <pc:sldMk cId="1988924823" sldId="558"/>
            <ac:spMk id="4" creationId="{7168E212-C2EC-C968-064D-3E5EA968BF21}"/>
          </ac:spMkLst>
        </pc:spChg>
        <pc:spChg chg="del">
          <ac:chgData name="David O'Neal" userId="56ebcf1a-7abb-4491-bf50-219a1885c9d7" providerId="ADAL" clId="{3FB753EA-8224-48E0-AB57-71EA79992FB6}" dt="2024-01-19T02:24:08.825" v="64" actId="478"/>
          <ac:spMkLst>
            <pc:docMk/>
            <pc:sldMk cId="1988924823" sldId="558"/>
            <ac:spMk id="14" creationId="{E79851DC-02ED-4939-A415-558B1B91E443}"/>
          </ac:spMkLst>
        </pc:spChg>
        <pc:grpChg chg="add mod">
          <ac:chgData name="David O'Neal" userId="56ebcf1a-7abb-4491-bf50-219a1885c9d7" providerId="ADAL" clId="{3FB753EA-8224-48E0-AB57-71EA79992FB6}" dt="2024-01-19T09:38:50.604" v="189" actId="164"/>
          <ac:grpSpMkLst>
            <pc:docMk/>
            <pc:sldMk cId="1988924823" sldId="558"/>
            <ac:grpSpMk id="5" creationId="{2E2E1E96-EE75-318C-ADE2-F23CFEB7FD6D}"/>
          </ac:grpSpMkLst>
        </pc:grpChg>
        <pc:picChg chg="mod">
          <ac:chgData name="David O'Neal" userId="56ebcf1a-7abb-4491-bf50-219a1885c9d7" providerId="ADAL" clId="{3FB753EA-8224-48E0-AB57-71EA79992FB6}" dt="2024-01-19T09:38:50.604" v="189" actId="164"/>
          <ac:picMkLst>
            <pc:docMk/>
            <pc:sldMk cId="1988924823" sldId="558"/>
            <ac:picMk id="3" creationId="{5099D6C1-5B42-CBB0-B75A-77EB2C4B2A43}"/>
          </ac:picMkLst>
        </pc:picChg>
        <pc:picChg chg="del">
          <ac:chgData name="David O'Neal" userId="56ebcf1a-7abb-4491-bf50-219a1885c9d7" providerId="ADAL" clId="{3FB753EA-8224-48E0-AB57-71EA79992FB6}" dt="2024-01-19T02:19:53.632" v="11" actId="478"/>
          <ac:picMkLst>
            <pc:docMk/>
            <pc:sldMk cId="1988924823" sldId="558"/>
            <ac:picMk id="4" creationId="{4526C67A-AE81-8D8F-468A-EEB02C5B996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6AB8E2-08CC-42B5-82C3-942373AABF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245839-C235-4943-9500-ECD1A45395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73BADC-C4C4-46F7-8D93-571E55B02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5D4E46-8095-4CAF-82CC-32B585BD8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A6D26A-6061-4AB4-8B70-BB427E563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16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DFD70-0531-4632-91EC-F75143834A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108E0F-F074-4C51-AF9C-72E32B3CCC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BBE7C8-C783-4F0A-B830-F1D95E438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56A6FB-DA50-4371-AE9C-8B8D70E6C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ECD632-1C25-45FB-B94C-F87651CA3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141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06640F-04C2-42A5-8485-1A80FB5B38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CCBC41-470B-49F0-B27C-F516EDCF1A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A0C21C-1D8A-4681-A532-8971E3275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F93F78-038B-48FB-A1BF-61998A909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56E8DE-2F3C-4FA7-9E74-4180D20C8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433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BE831-305D-4CF4-B593-E1D9AAC3C9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AF465-7DFA-42FC-9BD8-3F76EA63BE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EAB517-D4CC-43E6-A964-505DEA3B8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9D5F66-E669-4A33-B518-A6302D601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2361EA-BEAD-4B7A-8C47-1D3ED75EA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241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99F27-AD9A-4E7D-B6D3-6C783C09A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6ED3F-3CC1-4AA9-8ED9-41523B2DB4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DF78FB-A0B8-432A-BDE6-71B727F28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80B5E3-31A5-4277-B7BF-6AD262F55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F1F1AF-E342-4E56-8BB9-DB9E235C4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8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EF93D3-CBD0-43D9-AF89-AA126951E6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D80C8F-FB53-416B-9F16-34ECF88241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F0214D-5370-454A-A266-C57D9C5FEA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26FFA6-87FB-4EBA-A71A-AF6AF18EA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ABF957-6323-4A43-B3DD-2A7BA68F2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8F078A-B90B-4BC9-8751-B632A80A4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491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F0A040-1167-4606-9434-DDBC5FD292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175233-C5BC-432E-8043-3009B58A0D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C18A1E-6581-40B4-A2BD-3C3379AF1D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DF08242-30A1-4489-8EBA-4AE9CDCEE6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A57629-A7FB-4174-A250-797CF0BB02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6CBFD2-5EE5-4CD5-9772-43468980A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80C7C3-9A6C-44C2-8102-43CB87E9B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F0701E-2918-4408-A9F0-EB7A5B948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139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A7B8AA-3812-4595-8B21-E42F961727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1D7CF3-0F70-4419-8792-74BC79B83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79B00A0-E91A-47E1-8109-9AFA6673D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A72E0D7-8249-4515-8015-674D4E5D4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111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25BDF1-B991-4644-8CB2-CD3239D33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89CE3E-C6E6-4666-8BE9-42FD7F2C2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E71C4A-0051-4B07-AF72-3692BF535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317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9BBBC-8242-4895-9DF2-2C9187E108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9D0AD0-F920-4226-89FB-6F7B13B4C0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67D946-1258-4416-9ED7-2112FBAA35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E2A736-5A34-4F43-8585-71E4BBBC3E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6BCC86-B848-48C0-AC5B-59E8B25A7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16F868-AD66-42D2-B399-8546124A36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069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9CB047-1F20-400F-8E18-98D362984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992F17-90EE-4A80-B3DE-B60326BD9B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409212-CAC5-4340-A1AD-420CA5A7D6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0E8FB0-E2EE-44C1-9176-EE7A7F585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9D3061-6416-4819-924F-9500ABA0C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BAF676-B328-44E7-BDCF-870CC14EF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336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AA68DBF-5752-4551-8C64-BC869B9D9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DF1B71-CDCA-44F4-A060-9772241E06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5669F4-4923-4154-8276-9E62FB68E3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E20AB3-714D-4150-9FC2-FC3EB700A983}" type="datetimeFigureOut">
              <a:rPr lang="en-US" smtClean="0"/>
              <a:t>1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6A29D7-78C3-475C-B60F-E1ED820F60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E7613D-CE30-418B-9621-85288294BB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527D4-5F40-436E-AE52-C67A675B8B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937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3A2846-4A71-C539-F78E-8F87D620FC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>
              <a:solidFill>
                <a:schemeClr val="accent1"/>
              </a:solidFill>
            </a:endParaRPr>
          </a:p>
          <a:p>
            <a:endParaRPr lang="en-US" dirty="0">
              <a:solidFill>
                <a:schemeClr val="accent1"/>
              </a:solidFill>
            </a:endParaRPr>
          </a:p>
          <a:p>
            <a:pPr marL="0" indent="0" algn="ctr">
              <a:buNone/>
            </a:pPr>
            <a:r>
              <a:rPr lang="en-US" sz="6000" b="1" dirty="0">
                <a:solidFill>
                  <a:schemeClr val="accent1"/>
                </a:solidFill>
              </a:rPr>
              <a:t>Glucose and Insulin </a:t>
            </a:r>
            <a:r>
              <a:rPr lang="en-US" sz="6000" b="1">
                <a:solidFill>
                  <a:schemeClr val="accent1"/>
                </a:solidFill>
              </a:rPr>
              <a:t>Bolusing </a:t>
            </a:r>
            <a:r>
              <a:rPr lang="en-US" sz="6000" b="1" dirty="0">
                <a:solidFill>
                  <a:schemeClr val="accent1"/>
                </a:solidFill>
              </a:rPr>
              <a:t>Profiles</a:t>
            </a:r>
          </a:p>
        </p:txBody>
      </p:sp>
    </p:spTree>
    <p:extLst>
      <p:ext uri="{BB962C8B-B14F-4D97-AF65-F5344CB8AC3E}">
        <p14:creationId xmlns:p14="http://schemas.microsoft.com/office/powerpoint/2010/main" val="244171023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9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6032327-16E1-B8B6-07C9-DAAF8482E2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298" y="2052736"/>
            <a:ext cx="12006884" cy="2555790"/>
          </a:xfrm>
          <a:prstGeom prst="rect">
            <a:avLst/>
          </a:prstGeom>
        </p:spPr>
      </p:pic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FE325ECE-8CF0-CEA0-E353-539568C3D54C}"/>
              </a:ext>
            </a:extLst>
          </p:cNvPr>
          <p:cNvSpPr txBox="1">
            <a:spLocks/>
          </p:cNvSpPr>
          <p:nvPr/>
        </p:nvSpPr>
        <p:spPr>
          <a:xfrm>
            <a:off x="367437" y="4936166"/>
            <a:ext cx="11014919" cy="96085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</a:pPr>
            <a:r>
              <a:rPr lang="en-US" sz="1600" b="1" dirty="0">
                <a:solidFill>
                  <a:srgbClr val="C00000"/>
                </a:solidFill>
              </a:rPr>
              <a:t>*</a:t>
            </a:r>
            <a:r>
              <a:rPr lang="en-AU" sz="16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nsor failure during the first meal test while insulin continued to be delivered through the cannula though subsequent sensor data was obtained for the remainder of the study. </a:t>
            </a:r>
            <a:endParaRPr lang="en-US" sz="16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A1FD17E-ADE2-38DA-8D30-E60B90318D91}"/>
              </a:ext>
            </a:extLst>
          </p:cNvPr>
          <p:cNvSpPr/>
          <p:nvPr/>
        </p:nvSpPr>
        <p:spPr>
          <a:xfrm>
            <a:off x="5559490" y="2136709"/>
            <a:ext cx="1073020" cy="2239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E97E43E-98D1-C01B-2D56-A0865D3BBC0C}"/>
              </a:ext>
            </a:extLst>
          </p:cNvPr>
          <p:cNvSpPr/>
          <p:nvPr/>
        </p:nvSpPr>
        <p:spPr>
          <a:xfrm>
            <a:off x="5559490" y="2099385"/>
            <a:ext cx="1073020" cy="2239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430845B-1748-5728-B854-0FB8ACBDA9B8}"/>
              </a:ext>
            </a:extLst>
          </p:cNvPr>
          <p:cNvSpPr txBox="1"/>
          <p:nvPr/>
        </p:nvSpPr>
        <p:spPr>
          <a:xfrm>
            <a:off x="1278293" y="242968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>
                <a:solidFill>
                  <a:srgbClr val="C00000"/>
                </a:solidFill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9744781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10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153C75F-C133-AFF0-558F-C39EF9195CCF}"/>
              </a:ext>
            </a:extLst>
          </p:cNvPr>
          <p:cNvGrpSpPr/>
          <p:nvPr/>
        </p:nvGrpSpPr>
        <p:grpSpPr>
          <a:xfrm>
            <a:off x="102637" y="2056416"/>
            <a:ext cx="12023530" cy="2571567"/>
            <a:chOff x="102637" y="2056416"/>
            <a:chExt cx="12023530" cy="257156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691E8EC-D31C-DAA0-41A5-F25E27E3DD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2637" y="2056416"/>
              <a:ext cx="12023530" cy="2571567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D36215FB-31F2-035C-5D68-1CC15A23AA25}"/>
                </a:ext>
              </a:extLst>
            </p:cNvPr>
            <p:cNvSpPr/>
            <p:nvPr/>
          </p:nvSpPr>
          <p:spPr>
            <a:xfrm>
              <a:off x="5577892" y="2146039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29159051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11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F029C0F-E428-04C7-EDB4-833B41AD4BE6}"/>
              </a:ext>
            </a:extLst>
          </p:cNvPr>
          <p:cNvGrpSpPr/>
          <p:nvPr/>
        </p:nvGrpSpPr>
        <p:grpSpPr>
          <a:xfrm>
            <a:off x="165753" y="2043404"/>
            <a:ext cx="11975099" cy="2472612"/>
            <a:chOff x="165753" y="2043404"/>
            <a:chExt cx="11975099" cy="247261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23A66E0-E4CC-356A-3F7E-D20E62100B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5753" y="2043404"/>
              <a:ext cx="11975099" cy="2472612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BCEA7EA0-B65F-C59B-895E-69537C2DA9D1}"/>
                </a:ext>
              </a:extLst>
            </p:cNvPr>
            <p:cNvSpPr/>
            <p:nvPr/>
          </p:nvSpPr>
          <p:spPr>
            <a:xfrm>
              <a:off x="5616792" y="2118047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13062861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>
                <a:solidFill>
                  <a:schemeClr val="accent1"/>
                </a:solidFill>
                <a:latin typeface="+mn-lt"/>
              </a:rPr>
              <a:t>012</a:t>
            </a:r>
            <a:endParaRPr lang="en-US" sz="4000" b="1" dirty="0">
              <a:solidFill>
                <a:schemeClr val="accent1"/>
              </a:solidFill>
              <a:latin typeface="+mn-lt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E2E1E96-EE75-318C-ADE2-F23CFEB7FD6D}"/>
              </a:ext>
            </a:extLst>
          </p:cNvPr>
          <p:cNvGrpSpPr/>
          <p:nvPr/>
        </p:nvGrpSpPr>
        <p:grpSpPr>
          <a:xfrm>
            <a:off x="84416" y="1940768"/>
            <a:ext cx="12053078" cy="2789852"/>
            <a:chOff x="84416" y="1940768"/>
            <a:chExt cx="12053078" cy="278985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099D6C1-5B42-CBB0-B75A-77EB2C4B2A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416" y="1940768"/>
              <a:ext cx="12053078" cy="2789852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7168E212-C2EC-C968-064D-3E5EA968BF21}"/>
                </a:ext>
              </a:extLst>
            </p:cNvPr>
            <p:cNvSpPr/>
            <p:nvPr/>
          </p:nvSpPr>
          <p:spPr>
            <a:xfrm>
              <a:off x="5559490" y="2062063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1988924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1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20CAAEE-5382-BC1D-BCFC-864318B5330A}"/>
              </a:ext>
            </a:extLst>
          </p:cNvPr>
          <p:cNvGrpSpPr/>
          <p:nvPr/>
        </p:nvGrpSpPr>
        <p:grpSpPr>
          <a:xfrm>
            <a:off x="186612" y="2162313"/>
            <a:ext cx="11846694" cy="2724228"/>
            <a:chOff x="186612" y="2162313"/>
            <a:chExt cx="11846694" cy="272422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32A81B4-0F11-7E49-2E89-BE92B16C41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6612" y="2162313"/>
              <a:ext cx="11846694" cy="2724228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3C23CA75-9D0A-43B3-F61E-FE45D6BBE054}"/>
                </a:ext>
              </a:extLst>
            </p:cNvPr>
            <p:cNvSpPr/>
            <p:nvPr/>
          </p:nvSpPr>
          <p:spPr>
            <a:xfrm>
              <a:off x="5561045" y="2267337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3304879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6D788D2-039C-BDA3-E61D-216E9EF817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835" y="2332116"/>
            <a:ext cx="12079467" cy="255712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EE12F1B0-9292-3564-6653-85A4E3FA3115}"/>
              </a:ext>
            </a:extLst>
          </p:cNvPr>
          <p:cNvSpPr/>
          <p:nvPr/>
        </p:nvSpPr>
        <p:spPr>
          <a:xfrm>
            <a:off x="5623058" y="2435288"/>
            <a:ext cx="1073020" cy="2239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50920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0187D96-13D8-5F54-131D-EAE593E0CF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282" y="2147868"/>
            <a:ext cx="11837729" cy="2645304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605C983-F33A-EEE9-42DC-9A56C398B098}"/>
              </a:ext>
            </a:extLst>
          </p:cNvPr>
          <p:cNvSpPr/>
          <p:nvPr/>
        </p:nvSpPr>
        <p:spPr>
          <a:xfrm>
            <a:off x="5559490" y="2230015"/>
            <a:ext cx="1073020" cy="242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979209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4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9AE1E84-6DBE-91FB-4448-2C1987220392}"/>
              </a:ext>
            </a:extLst>
          </p:cNvPr>
          <p:cNvGrpSpPr/>
          <p:nvPr/>
        </p:nvGrpSpPr>
        <p:grpSpPr>
          <a:xfrm>
            <a:off x="125964" y="2162321"/>
            <a:ext cx="12040891" cy="2801565"/>
            <a:chOff x="125964" y="2162321"/>
            <a:chExt cx="12040891" cy="280156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5002525-D405-D86E-FE81-496A568802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5964" y="2162321"/>
              <a:ext cx="12040891" cy="2801565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1826938B-8E45-81FC-1B0F-3471B7C1214A}"/>
                </a:ext>
              </a:extLst>
            </p:cNvPr>
            <p:cNvSpPr/>
            <p:nvPr/>
          </p:nvSpPr>
          <p:spPr>
            <a:xfrm>
              <a:off x="5561045" y="2267337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38847565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5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6F4F786-30AF-E81B-BBB3-A21D216393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56" y="2062311"/>
            <a:ext cx="12193104" cy="2733624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CD2C784-E8F3-03F8-F24F-9D3AF4EE02F4}"/>
              </a:ext>
            </a:extLst>
          </p:cNvPr>
          <p:cNvSpPr/>
          <p:nvPr/>
        </p:nvSpPr>
        <p:spPr>
          <a:xfrm>
            <a:off x="5559490" y="2164701"/>
            <a:ext cx="1073020" cy="2239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24419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6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8DBD7D1-AD20-38B4-BCE6-1BE4D3C53D69}"/>
              </a:ext>
            </a:extLst>
          </p:cNvPr>
          <p:cNvGrpSpPr/>
          <p:nvPr/>
        </p:nvGrpSpPr>
        <p:grpSpPr>
          <a:xfrm>
            <a:off x="150166" y="2125837"/>
            <a:ext cx="12015183" cy="2772734"/>
            <a:chOff x="150166" y="2125837"/>
            <a:chExt cx="12015183" cy="277273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1781EA8-D04D-0A97-F69A-148AB343DF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0166" y="2125837"/>
              <a:ext cx="12015183" cy="2772734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28A85082-F48C-C017-402E-420F4E79EDB3}"/>
                </a:ext>
              </a:extLst>
            </p:cNvPr>
            <p:cNvSpPr/>
            <p:nvPr/>
          </p:nvSpPr>
          <p:spPr>
            <a:xfrm>
              <a:off x="5621247" y="2202023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29215075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7</a:t>
            </a:r>
          </a:p>
        </p:txBody>
      </p:sp>
      <p:sp>
        <p:nvSpPr>
          <p:cNvPr id="14" name="Content Placeholder 2">
            <a:extLst>
              <a:ext uri="{FF2B5EF4-FFF2-40B4-BE49-F238E27FC236}">
                <a16:creationId xmlns:a16="http://schemas.microsoft.com/office/drawing/2014/main" id="{E79851DC-02ED-4939-A415-558B1B91E4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7437" y="4936166"/>
            <a:ext cx="11014919" cy="960855"/>
          </a:xfrm>
        </p:spPr>
        <p:txBody>
          <a:bodyPr>
            <a:noAutofit/>
          </a:bodyPr>
          <a:lstStyle/>
          <a:p>
            <a:pPr marL="0" indent="0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None/>
            </a:pPr>
            <a:r>
              <a:rPr lang="en-US" sz="1600" b="1" dirty="0">
                <a:solidFill>
                  <a:srgbClr val="C00000"/>
                </a:solidFill>
              </a:rPr>
              <a:t>*</a:t>
            </a:r>
            <a:r>
              <a:rPr lang="en-US" sz="1600" dirty="0">
                <a:solidFill>
                  <a:schemeClr val="accent1">
                    <a:lumMod val="75000"/>
                  </a:schemeClr>
                </a:solidFill>
              </a:rPr>
              <a:t>Pump occlusions occurred at ~70 hours with removal of CGM-IS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1619A2F-A5DB-D15B-458F-C77B6EA321C6}"/>
              </a:ext>
            </a:extLst>
          </p:cNvPr>
          <p:cNvGrpSpPr/>
          <p:nvPr/>
        </p:nvGrpSpPr>
        <p:grpSpPr>
          <a:xfrm>
            <a:off x="75207" y="1963063"/>
            <a:ext cx="12013113" cy="2888855"/>
            <a:chOff x="75207" y="1963063"/>
            <a:chExt cx="12013113" cy="288885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D2EA9E0-6E50-E348-97B0-D18601F7B1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5207" y="1963063"/>
              <a:ext cx="12013113" cy="288885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32E65D5-C402-5D0E-D61B-EEE6D86786C6}"/>
                </a:ext>
              </a:extLst>
            </p:cNvPr>
            <p:cNvSpPr txBox="1"/>
            <p:nvPr/>
          </p:nvSpPr>
          <p:spPr>
            <a:xfrm>
              <a:off x="9834466" y="3429000"/>
              <a:ext cx="2332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b="1" dirty="0">
                  <a:solidFill>
                    <a:srgbClr val="C00000"/>
                  </a:solidFill>
                </a:rPr>
                <a:t>*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4C980F22-CFBE-6C28-39C1-0B844AE88F54}"/>
                </a:ext>
              </a:extLst>
            </p:cNvPr>
            <p:cNvSpPr/>
            <p:nvPr/>
          </p:nvSpPr>
          <p:spPr>
            <a:xfrm>
              <a:off x="5559490" y="2080725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4945289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9A2D4-D01D-42FE-85CB-71AC42D03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07076" y="266555"/>
            <a:ext cx="10177848" cy="651405"/>
          </a:xfrm>
        </p:spPr>
        <p:txBody>
          <a:bodyPr>
            <a:normAutofit/>
          </a:bodyPr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latin typeface="+mn-lt"/>
              </a:rPr>
              <a:t>008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5B9A9D19-7BA8-7DC9-2007-812109DEE912}"/>
              </a:ext>
            </a:extLst>
          </p:cNvPr>
          <p:cNvGrpSpPr/>
          <p:nvPr/>
        </p:nvGrpSpPr>
        <p:grpSpPr>
          <a:xfrm>
            <a:off x="51515" y="2006083"/>
            <a:ext cx="12042484" cy="2640562"/>
            <a:chOff x="51515" y="2006083"/>
            <a:chExt cx="12042484" cy="264056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E66112F-B325-A089-7ABB-7C833C71EA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515" y="2006083"/>
              <a:ext cx="12042484" cy="2640562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EF58944E-BE67-1C52-5771-07B30A343233}"/>
                </a:ext>
              </a:extLst>
            </p:cNvPr>
            <p:cNvSpPr/>
            <p:nvPr/>
          </p:nvSpPr>
          <p:spPr>
            <a:xfrm>
              <a:off x="5536247" y="2090056"/>
              <a:ext cx="1073020" cy="2239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</p:spTree>
    <p:extLst>
      <p:ext uri="{BB962C8B-B14F-4D97-AF65-F5344CB8AC3E}">
        <p14:creationId xmlns:p14="http://schemas.microsoft.com/office/powerpoint/2010/main" val="2582301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a3faf55-bd39-45d6-87d6-ad91ce5a15ec" xsi:nil="true"/>
    <lcf76f155ced4ddcb4097134ff3c332f xmlns="c75001d0-e160-4999-997b-0b8046f7ddab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A58D4878FDD084EBCBF7AFEF55E497A" ma:contentTypeVersion="15" ma:contentTypeDescription="Create a new document." ma:contentTypeScope="" ma:versionID="429c74fb904b75f2e181d42e16001683">
  <xsd:schema xmlns:xsd="http://www.w3.org/2001/XMLSchema" xmlns:xs="http://www.w3.org/2001/XMLSchema" xmlns:p="http://schemas.microsoft.com/office/2006/metadata/properties" xmlns:ns2="c75001d0-e160-4999-997b-0b8046f7ddab" xmlns:ns3="2a3faf55-bd39-45d6-87d6-ad91ce5a15ec" targetNamespace="http://schemas.microsoft.com/office/2006/metadata/properties" ma:root="true" ma:fieldsID="e0a3a3a093b14e9c53e84d01345c3686" ns2:_="" ns3:_="">
    <xsd:import namespace="c75001d0-e160-4999-997b-0b8046f7ddab"/>
    <xsd:import namespace="2a3faf55-bd39-45d6-87d6-ad91ce5a15e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5001d0-e160-4999-997b-0b8046f7dda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a89ea379-6ea2-4518-9c70-e5ea1a7c448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a3faf55-bd39-45d6-87d6-ad91ce5a15ec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3eef112f-a37c-45ab-a4ae-328fa19497d3}" ma:internalName="TaxCatchAll" ma:showField="CatchAllData" ma:web="2a3faf55-bd39-45d6-87d6-ad91ce5a15e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9770B17-0D67-4433-B436-73F3F89FFE7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6EDBAB4-1F18-42B9-AB51-20DB1B66913B}">
  <ds:schemaRefs>
    <ds:schemaRef ds:uri="c75001d0-e160-4999-997b-0b8046f7ddab"/>
    <ds:schemaRef ds:uri="2a3faf55-bd39-45d6-87d6-ad91ce5a15ec"/>
    <ds:schemaRef ds:uri="http://www.w3.org/XML/1998/namespace"/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C7ADCE1C-9A3C-4008-A0A3-DDC3FBA07750}">
  <ds:schemaRefs>
    <ds:schemaRef ds:uri="2a3faf55-bd39-45d6-87d6-ad91ce5a15ec"/>
    <ds:schemaRef ds:uri="c75001d0-e160-4999-997b-0b8046f7ddab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3685</TotalTime>
  <Words>62</Words>
  <Application>Microsoft Office PowerPoint</Application>
  <PresentationFormat>Widescreen</PresentationFormat>
  <Paragraphs>19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werPoint Presentation</vt:lpstr>
      <vt:lpstr>001</vt:lpstr>
      <vt:lpstr>002</vt:lpstr>
      <vt:lpstr>003</vt:lpstr>
      <vt:lpstr>004</vt:lpstr>
      <vt:lpstr>005</vt:lpstr>
      <vt:lpstr>006</vt:lpstr>
      <vt:lpstr>007</vt:lpstr>
      <vt:lpstr>008</vt:lpstr>
      <vt:lpstr>009</vt:lpstr>
      <vt:lpstr>010</vt:lpstr>
      <vt:lpstr>011</vt:lpstr>
      <vt:lpstr>01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liminary Report on PDT Recent Sensor Sessions</dc:title>
  <dc:creator>Huan-Ping</dc:creator>
  <cp:lastModifiedBy>David O'Neal</cp:lastModifiedBy>
  <cp:revision>535</cp:revision>
  <dcterms:created xsi:type="dcterms:W3CDTF">2021-04-13T13:01:01Z</dcterms:created>
  <dcterms:modified xsi:type="dcterms:W3CDTF">2024-01-19T09:42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8EC3B8FF6CFF344A58B0498D5DA9F11</vt:lpwstr>
  </property>
  <property fmtid="{D5CDD505-2E9C-101B-9397-08002B2CF9AE}" pid="3" name="MediaServiceImageTags">
    <vt:lpwstr/>
  </property>
</Properties>
</file>